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n, Nianzhen" initials="CN" lastIdx="1" clrIdx="0">
    <p:extLst>
      <p:ext uri="{19B8F6BF-5375-455C-9EA6-DF929625EA0E}">
        <p15:presenceInfo xmlns:p15="http://schemas.microsoft.com/office/powerpoint/2012/main" userId="S-1-5-21-2277552047-420188866-543257670-2365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10" autoAdjust="0"/>
    <p:restoredTop sz="94689"/>
  </p:normalViewPr>
  <p:slideViewPr>
    <p:cSldViewPr>
      <p:cViewPr varScale="1">
        <p:scale>
          <a:sx n="60" d="100"/>
          <a:sy n="60" d="100"/>
        </p:scale>
        <p:origin x="2064" y="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B42683-92B8-4941-9645-F1054BBB641D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9D4104-1F81-46B4-AD4B-BD240A61F4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6392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8604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473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9485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5390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1912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5231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5015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1476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064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996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3143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E77C7-081A-4E2E-9ADF-1565DF8F116C}" type="datetimeFigureOut">
              <a:rPr lang="de-DE" smtClean="0"/>
              <a:t>24.0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B914F-DE95-4E3A-B175-4AE180C1CC3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569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594" y="5617128"/>
            <a:ext cx="4050075" cy="2507194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15" y="2378770"/>
            <a:ext cx="3769360" cy="233341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6176" y="185385"/>
            <a:ext cx="2368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nuscript: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96176" y="2221134"/>
            <a:ext cx="3168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ncropped and unadjuste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s: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317564" y="3130923"/>
            <a:ext cx="63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ike</a:t>
            </a:r>
            <a:endParaRPr 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317564" y="5148064"/>
            <a:ext cx="63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SV-M</a:t>
            </a:r>
            <a:endParaRPr 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5500" y="3204483"/>
            <a:ext cx="969264" cy="107721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    Sampl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          Marker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No spike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    JN.1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          KP.3.1.1</a:t>
            </a:r>
          </a:p>
          <a:p>
            <a:pPr marL="228600" indent="-228600">
              <a:buAutoNum type="arabicPlain" startAt="5"/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XEC</a:t>
            </a:r>
          </a:p>
          <a:p>
            <a:pPr marL="228600" indent="-228600">
              <a:buAutoNum type="arabicPlain" startAt="5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VSV-G</a:t>
            </a:r>
          </a:p>
          <a:p>
            <a:pPr marL="228600" indent="-228600">
              <a:buAutoNum type="arabicPlain" startAt="5"/>
            </a:pP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685487" y="3785372"/>
            <a:ext cx="1103435" cy="194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1304764" y="3866202"/>
            <a:ext cx="352504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2470" y="2915816"/>
            <a:ext cx="2557183" cy="1583018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742552" y="3029635"/>
            <a:ext cx="63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2918" y="5508104"/>
            <a:ext cx="2559050" cy="1584176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4731670" y="6245456"/>
            <a:ext cx="630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7506" y="5548022"/>
            <a:ext cx="969264" cy="107721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    Sampl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          Marker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No spike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    JN.1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          KP.3.1.1</a:t>
            </a:r>
          </a:p>
          <a:p>
            <a:pPr marL="228600" indent="-228600">
              <a:buAutoNum type="arabicPlain" startAt="5"/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XEC</a:t>
            </a:r>
          </a:p>
          <a:p>
            <a:pPr marL="228600" indent="-228600">
              <a:buAutoNum type="arabicPlain" startAt="5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VSV-G</a:t>
            </a:r>
          </a:p>
          <a:p>
            <a:pPr marL="228600" indent="-228600">
              <a:buAutoNum type="arabicPlain" startAt="5"/>
            </a:pPr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1677493" y="6128911"/>
            <a:ext cx="1103435" cy="194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Arrow Connector 29"/>
          <p:cNvCxnSpPr/>
          <p:nvPr/>
        </p:nvCxnSpPr>
        <p:spPr>
          <a:xfrm flipH="1">
            <a:off x="1296770" y="6209741"/>
            <a:ext cx="352504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Picture 1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64904" y="479239"/>
            <a:ext cx="2444633" cy="16630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6042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ntensity ratio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88840" y="2483768"/>
            <a:ext cx="3456384" cy="265139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6792" y="5728748"/>
            <a:ext cx="4006850" cy="74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789102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2</TotalTime>
  <Words>49</Words>
  <Application>Microsoft Office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Times New Roman</vt:lpstr>
      <vt:lpstr>Larissa</vt:lpstr>
      <vt:lpstr>PowerPoint Presentation</vt:lpstr>
      <vt:lpstr>Intensity ratio</vt:lpstr>
    </vt:vector>
  </TitlesOfParts>
  <Company>Deutsches Primatenzentrum Gm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frica follow up</dc:title>
  <dc:creator>Kleine-Weber, Hannah</dc:creator>
  <cp:lastModifiedBy>Arora, Prerna</cp:lastModifiedBy>
  <cp:revision>224</cp:revision>
  <dcterms:created xsi:type="dcterms:W3CDTF">2019-12-02T12:04:14Z</dcterms:created>
  <dcterms:modified xsi:type="dcterms:W3CDTF">2025-02-24T22:45:12Z</dcterms:modified>
</cp:coreProperties>
</file>